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B83C8-6A0F-4621-8DFA-C4CC7E766C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969FB3-B939-4AF7-97C1-137AA3B799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C3C51-7028-497F-96A9-0738B6BA48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B89DB7-2EB3-4B57-9157-F63017BE8E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4A03B-17EE-4896-A7AF-7B9F0810F9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AB5CB2-3334-4E4A-A9B7-CEC925126F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B4E0B-1C19-4D76-9A3B-7F93A7EA65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3AA934-F2D7-4C23-BCE2-511D062331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298B2B-84F3-46E3-871C-694AB009C6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52B84-2F10-4637-9C56-5A4B131F97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EC019C-259B-4375-B2BF-B452B330F4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DBA96-A985-4190-AF3B-F1D5D717A1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964921-F0BD-4B8E-AF8F-D714DC8B750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16"/>
          <p:cNvSpPr/>
          <p:nvPr/>
        </p:nvSpPr>
        <p:spPr>
          <a:xfrm>
            <a:off x="611280" y="304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817"/>
          <p:cNvSpPr/>
          <p:nvPr/>
        </p:nvSpPr>
        <p:spPr>
          <a:xfrm>
            <a:off x="609480" y="1828800"/>
            <a:ext cx="330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818"/>
          <p:cNvSpPr/>
          <p:nvPr/>
        </p:nvSpPr>
        <p:spPr>
          <a:xfrm>
            <a:off x="611280" y="32767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851"/>
          <p:cNvGrpSpPr/>
          <p:nvPr/>
        </p:nvGrpSpPr>
        <p:grpSpPr>
          <a:xfrm>
            <a:off x="838080" y="1905120"/>
            <a:ext cx="5248440" cy="1733400"/>
            <a:chOff x="838080" y="1905120"/>
            <a:chExt cx="5248440" cy="1733400"/>
          </a:xfrm>
        </p:grpSpPr>
        <p:pic>
          <p:nvPicPr>
            <p:cNvPr id="45" name="Object 849" descr=""/>
            <p:cNvPicPr/>
            <p:nvPr/>
          </p:nvPicPr>
          <p:blipFill>
            <a:blip r:embed="rId1"/>
            <a:stretch/>
          </p:blipFill>
          <p:spPr>
            <a:xfrm>
              <a:off x="838080" y="1905120"/>
              <a:ext cx="5248440" cy="173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 Box 850"/>
            <p:cNvSpPr/>
            <p:nvPr/>
          </p:nvSpPr>
          <p:spPr>
            <a:xfrm>
              <a:off x="1600920" y="2057400"/>
              <a:ext cx="56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JAG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Group 854"/>
          <p:cNvGrpSpPr/>
          <p:nvPr/>
        </p:nvGrpSpPr>
        <p:grpSpPr>
          <a:xfrm>
            <a:off x="914400" y="3352680"/>
            <a:ext cx="5143680" cy="1733760"/>
            <a:chOff x="914400" y="3352680"/>
            <a:chExt cx="5143680" cy="1733760"/>
          </a:xfrm>
        </p:grpSpPr>
        <p:pic>
          <p:nvPicPr>
            <p:cNvPr id="48" name="Object 852" descr=""/>
            <p:cNvPicPr/>
            <p:nvPr/>
          </p:nvPicPr>
          <p:blipFill>
            <a:blip r:embed="rId2"/>
            <a:stretch/>
          </p:blipFill>
          <p:spPr>
            <a:xfrm>
              <a:off x="914400" y="3352680"/>
              <a:ext cx="5143680" cy="1733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Text Box 853"/>
            <p:cNvSpPr/>
            <p:nvPr/>
          </p:nvSpPr>
          <p:spPr>
            <a:xfrm>
              <a:off x="1752840" y="349848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es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Group 858"/>
          <p:cNvGrpSpPr/>
          <p:nvPr/>
        </p:nvGrpSpPr>
        <p:grpSpPr>
          <a:xfrm>
            <a:off x="914400" y="4952880"/>
            <a:ext cx="5248080" cy="1600200"/>
            <a:chOff x="914400" y="4952880"/>
            <a:chExt cx="5248080" cy="1600200"/>
          </a:xfrm>
        </p:grpSpPr>
        <p:pic>
          <p:nvPicPr>
            <p:cNvPr id="51" name="Object 856" descr=""/>
            <p:cNvPicPr/>
            <p:nvPr/>
          </p:nvPicPr>
          <p:blipFill>
            <a:blip r:embed="rId3"/>
            <a:stretch/>
          </p:blipFill>
          <p:spPr>
            <a:xfrm>
              <a:off x="914400" y="4952880"/>
              <a:ext cx="5248080" cy="1600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Text Box 857"/>
            <p:cNvSpPr/>
            <p:nvPr/>
          </p:nvSpPr>
          <p:spPr>
            <a:xfrm>
              <a:off x="1752840" y="510516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es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Text Box 859"/>
          <p:cNvSpPr/>
          <p:nvPr/>
        </p:nvSpPr>
        <p:spPr>
          <a:xfrm>
            <a:off x="611280" y="48769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861"/>
          <p:cNvSpPr/>
          <p:nvPr/>
        </p:nvSpPr>
        <p:spPr>
          <a:xfrm>
            <a:off x="6400800" y="2743200"/>
            <a:ext cx="1981080" cy="283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l Figure 1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pressio of Notch3, JAG1, Hes4 and Hes2 in normal bone marrow (BM), CD34+ BM, BMs  from patients with T cell acute lymphoblastic leukemia (T-ALL), B-ALL, and various leukemia cell lines. The relative gene expression was determined by real-time PCR assays and normalized to that of GAPDH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5" name="Group 867"/>
          <p:cNvGrpSpPr/>
          <p:nvPr/>
        </p:nvGrpSpPr>
        <p:grpSpPr>
          <a:xfrm>
            <a:off x="914400" y="380880"/>
            <a:ext cx="5257800" cy="1647720"/>
            <a:chOff x="914400" y="380880"/>
            <a:chExt cx="5257800" cy="1647720"/>
          </a:xfrm>
        </p:grpSpPr>
        <p:pic>
          <p:nvPicPr>
            <p:cNvPr id="56" name="Object 865" descr=""/>
            <p:cNvPicPr/>
            <p:nvPr/>
          </p:nvPicPr>
          <p:blipFill>
            <a:blip r:embed="rId4"/>
            <a:stretch/>
          </p:blipFill>
          <p:spPr>
            <a:xfrm>
              <a:off x="914400" y="380880"/>
              <a:ext cx="5257800" cy="1647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7" name="Text Box 866"/>
            <p:cNvSpPr/>
            <p:nvPr/>
          </p:nvSpPr>
          <p:spPr>
            <a:xfrm>
              <a:off x="1510560" y="457200"/>
              <a:ext cx="66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tch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8T01:58:31Z</dcterms:created>
  <dc:creator>SKuang</dc:creator>
  <dc:description/>
  <dc:language>en-US</dc:language>
  <cp:lastModifiedBy>skuang</cp:lastModifiedBy>
  <dcterms:modified xsi:type="dcterms:W3CDTF">2009-03-29T04:32:06Z</dcterms:modified>
  <cp:revision>71</cp:revision>
  <dc:subject/>
  <dc:title>Slide 1</dc:title>
</cp:coreProperties>
</file>